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00" autoAdjust="0"/>
    <p:restoredTop sz="94660"/>
  </p:normalViewPr>
  <p:slideViewPr>
    <p:cSldViewPr snapToGrid="0">
      <p:cViewPr varScale="1">
        <p:scale>
          <a:sx n="159" d="100"/>
          <a:sy n="159" d="100"/>
        </p:scale>
        <p:origin x="150" y="4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A241F-EDAB-B3B6-1DB8-C0970F7A28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775408-714B-7B21-531C-A1987FD0BA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5DB1A2-3EE7-C725-19DE-3C83889817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000467-72A9-5DFE-43F8-AE51287052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43DA9B-DA95-1C17-3BA0-89F7E5888D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096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CC4EC4-CD6D-73AC-F436-564930890D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8AB33A-DE74-64BC-B3BD-8141522A24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31B6CE-8B55-D255-CF8C-1BA556BEA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F42C53-652F-532D-9C69-98B702ECC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2CF430-8EA4-BABE-14D5-BAD2CAD9E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332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2AE1DCA-5870-8046-8F48-486361EB694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15D571-8A76-2D37-838D-8003EA781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AFBCEE-9B1C-90EF-245B-E042E864A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84F253-4BE7-9041-F136-921919217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64C0E5-6D2B-8FC1-077E-7EE648BCD6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421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889BF6-2533-AB29-768E-620EF454C5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81F6C3-884B-1ED1-6E5E-EC1FC0A4DC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D898A5-4388-0ADC-895D-A817C59CF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FCB08F-0FD5-8215-D828-F9974A1BD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CFDFA4-5856-B279-C91F-85C0F7DD6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728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D7ECE1-AFC4-EE0A-5551-B8C72CAD45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ED4C61-D016-CB2D-72ED-3FF0E48585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384FA6-7674-4EE1-88E0-9FB9BF621D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876C20-970D-DA36-DF64-37CBB1725B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4701B1-528C-1B0C-79EA-C1248D37D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0505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E01492-8107-7AB4-63B2-77953A797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726A55-B655-D2BF-9FA1-709B444FF3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0B261DA-B198-3CC3-FFFB-698A8FA318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4C6A27-487F-2F12-9717-01682B3821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C21A8A-BB39-DB76-8FC6-2658AC709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C97DA2-C586-5A39-0C01-BFE134502B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001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FA9EF6-AFAE-9315-FA02-9EF67468BD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F3EBD5-2511-F50E-F083-82BD5A0FF5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3D9B3E-F299-9950-5176-F9C68D62E2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865106-97D0-D83A-D98E-3E29D4480A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C9BB87A-62C0-9129-832E-8391F2106E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29EAFA5-1187-6E11-5F02-7CBA971B2B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612EE-A120-17E2-92B4-F9E5AFB1A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1B94B7B-9BD2-61E0-7E66-CC799EBBB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5426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9FC9D1-4B10-6D93-4B9D-A28330CA5B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C0AA46-D64E-98E4-B2A4-61D7C734B8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04445EB-2EA7-9995-AEBA-4C38B84E9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62C5C41-DB51-F081-2194-98C054905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3510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61BAFE-6D2C-7F63-2C17-55D095934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825F4C-533A-3A61-EE11-71B80B434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2AC257D-0580-693A-110C-3448FC61D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5926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CB9336-1D3C-CF7F-3182-15665F1633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D6E668-1F8B-DC12-1D1C-93B7E2E0829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971036-D781-5092-0C93-9D73D38B63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64E89A-865C-411B-EC11-575BBD83C7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F6B440-93E9-4705-6219-06D5E00D8D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0AD86D-98C7-0A01-62F3-591452926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932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110B8-4E21-4F1E-8978-B6AC3CABF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45E2B9-6E28-6B41-A10E-1FD93343B3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F40D3-A3AE-3F82-7FAE-AC7BC574DE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F32AC0-FC94-3116-E5EF-1021A5268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3D5398-058D-1692-974A-DBA563600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C66B2A-A18C-1F2C-94AB-307A01523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376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B882EFD-F052-DFDC-18E8-F7A082C988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4DBBFD-6313-278D-03C4-05B6C74503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B0A3FC-F39C-3F4F-3252-F5F8219F0E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38197A9-468A-4A38-B2D3-6F35D1BAED43}" type="datetimeFigureOut">
              <a:rPr lang="en-US" smtClean="0"/>
              <a:t>5/6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05321A-7098-DFD1-5C79-0F277D516C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9C43DC-5903-52E2-06AA-68F332BA56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A1841C9-A368-4590-9A57-AA673AEEE4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618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DC3BCD7-15F0-5158-9976-40E166732B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4840" y="54142"/>
            <a:ext cx="6082169" cy="385944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D68079B-A3E0-860A-53E5-8B2E55DB37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6668" y="3913591"/>
            <a:ext cx="9824644" cy="289677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A370E5F-1A24-A24B-C363-BD187C91FF34}"/>
              </a:ext>
            </a:extLst>
          </p:cNvPr>
          <p:cNvSpPr txBox="1"/>
          <p:nvPr/>
        </p:nvSpPr>
        <p:spPr>
          <a:xfrm>
            <a:off x="3580330" y="1559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434DC20-0E05-C0D5-17FA-D0469C98AF48}"/>
              </a:ext>
            </a:extLst>
          </p:cNvPr>
          <p:cNvSpPr txBox="1"/>
          <p:nvPr/>
        </p:nvSpPr>
        <p:spPr>
          <a:xfrm>
            <a:off x="2137959" y="39135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A99FC79-F589-E641-B2EB-B4318007B0D8}"/>
              </a:ext>
            </a:extLst>
          </p:cNvPr>
          <p:cNvSpPr txBox="1"/>
          <p:nvPr/>
        </p:nvSpPr>
        <p:spPr>
          <a:xfrm>
            <a:off x="62404" y="709366"/>
            <a:ext cx="3517926" cy="30280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lnSpc>
                <a:spcPct val="200000"/>
              </a:lnSpc>
              <a:spcAft>
                <a:spcPts val="800"/>
              </a:spcAft>
              <a:buNone/>
            </a:pPr>
            <a:r>
              <a:rPr lang="en-US" sz="900" b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Supplementary Fig. 2 </a:t>
            </a:r>
            <a:r>
              <a:rPr lang="en-US" sz="9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EEG-sEMG back-averaging for patient #1</a:t>
            </a:r>
          </a:p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A) Raw EEG-sEMG tracing for a clonic seizure with EEG correlate (same seizure as in Fig. 5B) shows a clear biphasic spike localized to the right peri-rolandic region with an initial maximum positivity at C4. EEG-EMG latency ~19ms. </a:t>
            </a:r>
          </a:p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9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(B) Back-averaged tracing for a clonic seizure without scalp-EEG correlate (same seizure as in Fig. 5A) using C4-A1 as the EEG channel shows a clear biphasic spike with an initial maximum positivity at C4, like (A). Back-averaging was performed using the online platform </a:t>
            </a:r>
            <a:r>
              <a:rPr lang="en-US" sz="9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BacAv</a:t>
            </a:r>
            <a:r>
              <a:rPr lang="en-US" sz="9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4105402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11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mbria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Fotedar, Neel</dc:creator>
  <cp:lastModifiedBy>Fotedar, Neel</cp:lastModifiedBy>
  <cp:revision>4</cp:revision>
  <dcterms:created xsi:type="dcterms:W3CDTF">2024-12-30T00:44:34Z</dcterms:created>
  <dcterms:modified xsi:type="dcterms:W3CDTF">2025-05-06T17:55:39Z</dcterms:modified>
</cp:coreProperties>
</file>